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57" r:id="rId5"/>
    <p:sldId id="258" r:id="rId6"/>
    <p:sldId id="262" r:id="rId7"/>
    <p:sldId id="259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832" y="184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E47FE-0C2A-4701-ACF6-B9E7624340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5974BCD-BF61-4CE4-B249-86EC407ACE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2CC613-C0C4-4D42-944F-93107E186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D9A673-A33F-46DD-8DA4-DD2670091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7BD075-D9AA-4D55-9082-12A1CBEBE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7327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F4EC76-59B1-49A6-8226-AE128958F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54B14D-9928-4245-B179-E2CC55261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164743-82AA-49AD-9F35-CB8C92365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550D36-97C5-4085-9D8B-4DE7D8B52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FB4E3D-E9B3-4645-99F8-81AAFEA7B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2580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31E70FB-3A5B-458A-B1A4-616D56545B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4CADCA8-80B4-4801-AA95-BAA58E910A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799515-33D3-4757-974B-B9DC92CCD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0B289D-2889-4BB6-81FE-7F47D3098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63B0DB-97CF-4629-886E-165355305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750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958BC2-A97B-4A13-82C6-E8CBA0630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A9AC60-19B0-4750-8B19-E8C7E184FE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C8BA0C-44ED-43FE-A298-0F7F29708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F66F79-BDA6-488E-8A90-87B85A416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4BCBDB-52B1-4F15-BD6F-027625F45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6740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86F6E4-F120-46E0-B7F1-D50D9D7B5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408C13-039E-4D35-81D0-2395EDC259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E5A8E8-F4A0-4C9B-AE1B-59E4E29D7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3F98DC-E34C-45AB-98B8-714F32913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FECEF6-F235-4A27-A36E-2C0BFA95E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8600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9B7D0C-DA9E-414C-971D-76EAC5B22F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201E4F3-3F77-4291-A85F-E4E06530AD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251939-2644-45D6-9F85-BD8E36284B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4EB8D4-F32B-429F-B856-3D1D26C7A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9243A5-3FC4-412E-87FD-C5E81BB91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2FD09A-2F3F-49E0-A906-E5DFBCB8B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8504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F4BF2-9A40-4596-95BE-4A73FAB9C9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464446-FDCB-48C1-A445-29A4C90F5D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E79CBA1-9165-4CFC-B82B-CE252DA49F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5BB6481-2C0E-4C1C-8E99-F4B75D6DD4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32B376C-3513-4827-878F-F6570BEE5F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29D71D1-93BF-4E1E-BFEE-7A3266A38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64FD51-C701-4898-92F6-6F87AFD82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81960A3-072D-4AE3-9FF6-9882B0D37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9444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93B8CC-2183-436C-BFC9-9B06FC2CF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160DA89-9050-440C-B706-D7056EAC1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B2CB16C-624C-425E-9947-000885657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D10571A-B8C7-4C10-A194-C3A6096A0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113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28EE97D-A252-4615-BA80-C1A855D1D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018A4D2-016A-4984-8E17-34272D5BE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E21F75B-B478-4CF8-AC3B-AD7DE05C2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0217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2E89FA-7631-4916-A5D2-F6C3F5796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1B9C1F8-427F-4725-8A73-12AF2F7526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8E20498-0ED9-4616-914B-2D25C12E2F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EB60F39-4088-4B4B-B950-C083C162E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21D6E6-FCF1-49DE-B800-D61F11ACB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26EE04-DF03-4798-96A2-099D4D1CC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23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DC09D2-A446-4464-97B3-4290CC9A5E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73B93BA-DFCE-44B5-B7A1-991E237601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CC3902B-7B35-4402-8154-5D46831630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386D1C-7069-4906-82EC-23B779C7B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D229D20-6AEC-450A-92E5-65BC91B5F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54829D-795F-46E9-A01C-A15BD2519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9087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5353E77-254B-4BFA-A8C6-9FF03BCCD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7834A4-1595-4450-AFB2-252F5CBE3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BA634D-91A7-4C74-813A-29680295FB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724A2-8BC5-4096-8B8B-49B6E8325F73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2ABC07-2CCE-4949-86CB-A99BB265CD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9B4484-027A-4468-8AE9-3159521A59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37F3C-2C1A-4DBC-98F9-966F6966D3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9655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" Type="http://schemas.openxmlformats.org/officeDocument/2006/relationships/image" Target="../media/image5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16.png"/><Relationship Id="rId18" Type="http://schemas.openxmlformats.org/officeDocument/2006/relationships/image" Target="../media/image12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15.png"/><Relationship Id="rId17" Type="http://schemas.openxmlformats.org/officeDocument/2006/relationships/image" Target="../media/image11.png"/><Relationship Id="rId2" Type="http://schemas.openxmlformats.org/officeDocument/2006/relationships/image" Target="../media/image25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14.png"/><Relationship Id="rId5" Type="http://schemas.openxmlformats.org/officeDocument/2006/relationships/image" Target="../media/image28.png"/><Relationship Id="rId15" Type="http://schemas.openxmlformats.org/officeDocument/2006/relationships/image" Target="../media/image9.png"/><Relationship Id="rId10" Type="http://schemas.openxmlformats.org/officeDocument/2006/relationships/image" Target="../media/image1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0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11" Type="http://schemas.openxmlformats.org/officeDocument/2006/relationships/image" Target="../media/image8.png"/><Relationship Id="rId5" Type="http://schemas.openxmlformats.org/officeDocument/2006/relationships/image" Target="../media/image37.png"/><Relationship Id="rId10" Type="http://schemas.openxmlformats.org/officeDocument/2006/relationships/image" Target="../media/image7.png"/><Relationship Id="rId4" Type="http://schemas.openxmlformats.org/officeDocument/2006/relationships/image" Target="../media/image36.png"/><Relationship Id="rId9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tiff"/><Relationship Id="rId3" Type="http://schemas.openxmlformats.org/officeDocument/2006/relationships/image" Target="../media/image42.tiff"/><Relationship Id="rId7" Type="http://schemas.openxmlformats.org/officeDocument/2006/relationships/image" Target="../media/image46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tiff"/><Relationship Id="rId11" Type="http://schemas.openxmlformats.org/officeDocument/2006/relationships/image" Target="../media/image50.tiff"/><Relationship Id="rId5" Type="http://schemas.openxmlformats.org/officeDocument/2006/relationships/image" Target="../media/image44.tiff"/><Relationship Id="rId10" Type="http://schemas.openxmlformats.org/officeDocument/2006/relationships/image" Target="../media/image49.tiff"/><Relationship Id="rId4" Type="http://schemas.openxmlformats.org/officeDocument/2006/relationships/image" Target="../media/image43.tiff"/><Relationship Id="rId9" Type="http://schemas.openxmlformats.org/officeDocument/2006/relationships/image" Target="../media/image4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A038122-3843-40DF-9FCD-6A17D1A81BD2}"/>
              </a:ext>
            </a:extLst>
          </p:cNvPr>
          <p:cNvSpPr txBox="1"/>
          <p:nvPr/>
        </p:nvSpPr>
        <p:spPr>
          <a:xfrm flipH="1">
            <a:off x="114569" y="476531"/>
            <a:ext cx="39756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OXPHOS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988611D-74EA-4E97-89F4-DA9C739A70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5636" y="217365"/>
            <a:ext cx="4127712" cy="255283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839F509-69CE-4CEB-9AE9-1A7DEB46C0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5435" y="217365"/>
            <a:ext cx="4095961" cy="260998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96F195E-0C8C-42D0-84A1-A2C280CD15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5636" y="3582921"/>
            <a:ext cx="4254719" cy="262903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4585047-F08C-4D4E-A256-EC99F5613A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40403" y="3582921"/>
            <a:ext cx="4095961" cy="2721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2140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12E86340-1D54-4D92-B089-FBB11F1621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7405" y="3608097"/>
            <a:ext cx="2460183" cy="35230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CB96D59-342A-491B-A73F-C6C38554C8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7405" y="4169951"/>
            <a:ext cx="2460183" cy="344776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21703BC-E2EC-44CF-AA2E-B770081BD5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20158" y="4731804"/>
            <a:ext cx="2527430" cy="412771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9BAE7B5-46A9-4893-B887-6FF8CEB31D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85232" y="5272694"/>
            <a:ext cx="2527430" cy="389311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9D930B1B-21DC-425A-8081-327CEF082CDB}"/>
              </a:ext>
            </a:extLst>
          </p:cNvPr>
          <p:cNvSpPr txBox="1"/>
          <p:nvPr/>
        </p:nvSpPr>
        <p:spPr>
          <a:xfrm>
            <a:off x="6096000" y="4075046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AE93BCD9-EC9E-44B8-BA88-1166F75FAA7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96212" y="646978"/>
            <a:ext cx="2686188" cy="450873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7FD59AB2-5F3C-4C00-AA52-380B0292F4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32991" y="1211922"/>
            <a:ext cx="2789647" cy="408078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177A291-9833-4338-B4F2-3702D0BBC01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8313" y="1697660"/>
            <a:ext cx="2734087" cy="423783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BA09142-E8BD-479D-B2FC-6798AD7A0F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96212" y="2163647"/>
            <a:ext cx="2726426" cy="439297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CCBABD8C-F79E-44A3-8F00-EF32587F1927}"/>
              </a:ext>
            </a:extLst>
          </p:cNvPr>
          <p:cNvSpPr txBox="1"/>
          <p:nvPr/>
        </p:nvSpPr>
        <p:spPr>
          <a:xfrm>
            <a:off x="477079" y="1461053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yt</a:t>
            </a:r>
            <a:r>
              <a:rPr lang="en-US" altLang="zh-CN" dirty="0"/>
              <a:t> C</a:t>
            </a:r>
            <a:endParaRPr lang="zh-CN" altLang="en-US" dirty="0"/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2D8B286E-842B-40D0-9F79-9905B7BA349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40664" y="3812140"/>
            <a:ext cx="2629035" cy="323867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895BE988-1735-42E7-8044-204990948D0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40664" y="4321249"/>
            <a:ext cx="2641736" cy="368319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25DD9C54-CE83-46CC-9B58-744176E6D07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40665" y="4855953"/>
            <a:ext cx="2609984" cy="327628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74A31A66-9927-49BD-B24F-D0870B5B599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96212" y="5451525"/>
            <a:ext cx="2648086" cy="368319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CA2CB876-8DB3-42B3-9DF5-14728A88E581}"/>
              </a:ext>
            </a:extLst>
          </p:cNvPr>
          <p:cNvSpPr txBox="1"/>
          <p:nvPr/>
        </p:nvSpPr>
        <p:spPr>
          <a:xfrm>
            <a:off x="511064" y="4321249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SD95</a:t>
            </a:r>
            <a:endParaRPr lang="zh-CN" altLang="en-US" dirty="0"/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F39B52F7-AC79-466B-AED1-F470FA0F2CF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30986" y="1627925"/>
            <a:ext cx="2629035" cy="400071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77FA5AAD-EFD8-4563-AE1A-6A8A22C54D2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220158" y="2285428"/>
            <a:ext cx="2635385" cy="317516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12A740E7-452F-4A1F-A5CA-9968D9CCAEB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061132" y="523027"/>
            <a:ext cx="2698889" cy="323867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3848B446-B1C9-4483-98ED-D7AB8E0F0DF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146861" y="1104052"/>
            <a:ext cx="2527430" cy="266714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D150223B-DB10-4883-9877-905F96BB2E4C}"/>
              </a:ext>
            </a:extLst>
          </p:cNvPr>
          <p:cNvSpPr txBox="1"/>
          <p:nvPr/>
        </p:nvSpPr>
        <p:spPr>
          <a:xfrm>
            <a:off x="6142383" y="684960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fn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699118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2E4C294-89CD-486C-B98D-E4178BC35E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7200" y="1013450"/>
            <a:ext cx="2870348" cy="36196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9712059-2D0D-42E1-A5A5-FFFB7A6FDC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7200" y="1554579"/>
            <a:ext cx="2870348" cy="41277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6B73E33-1F22-41C4-98D8-B97370DD32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7200" y="2201194"/>
            <a:ext cx="2870348" cy="39866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9AB3CE7-0793-452E-9F3E-E04734DC63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87200" y="2782189"/>
            <a:ext cx="2870348" cy="39439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6F5517E-36AE-45DF-9A17-1949FB80E659}"/>
              </a:ext>
            </a:extLst>
          </p:cNvPr>
          <p:cNvSpPr txBox="1"/>
          <p:nvPr/>
        </p:nvSpPr>
        <p:spPr>
          <a:xfrm>
            <a:off x="831537" y="1514768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omm2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22470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CEA07F1-DCD8-4F68-86D2-1349171446F6}"/>
              </a:ext>
            </a:extLst>
          </p:cNvPr>
          <p:cNvSpPr txBox="1"/>
          <p:nvPr/>
        </p:nvSpPr>
        <p:spPr>
          <a:xfrm>
            <a:off x="556591" y="437321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A1A7B47-47EE-44AB-A243-EA8936EC21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4257" y="417443"/>
            <a:ext cx="2800494" cy="50802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906AC7A-5F89-4748-9CAB-B2610006C4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4257" y="1126283"/>
            <a:ext cx="2730640" cy="45087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2065389-1A97-42E5-B1A3-2251116C72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4585" y="1850600"/>
            <a:ext cx="2679838" cy="39372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5601FB5-55CF-4870-8DC4-AE8ED156B2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44111" y="2425147"/>
            <a:ext cx="2730640" cy="48262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D300838-64BD-481D-86E7-A63C597C0D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06801" y="214232"/>
            <a:ext cx="3524431" cy="40642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B9B0ED6-F7F8-4B41-935A-E872C68E572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06801" y="989750"/>
            <a:ext cx="3486329" cy="361969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1BC3F84-CF55-4586-942F-0B3BB88163A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06801" y="1577156"/>
            <a:ext cx="3486329" cy="376142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38EABEA-6F80-46ED-AEBC-5C9DE7EC6E1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106801" y="2233918"/>
            <a:ext cx="3486329" cy="426427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561D1566-4B3B-45DE-AED5-F0760BCB8D25}"/>
              </a:ext>
            </a:extLst>
          </p:cNvPr>
          <p:cNvSpPr txBox="1"/>
          <p:nvPr/>
        </p:nvSpPr>
        <p:spPr>
          <a:xfrm>
            <a:off x="6013174" y="417443"/>
            <a:ext cx="822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AKT</a:t>
            </a:r>
            <a:endParaRPr lang="zh-CN" altLang="en-US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77BDA1EC-9CCC-4C57-B065-3854789069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94913" y="3714181"/>
            <a:ext cx="2629035" cy="323867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71F0318-B882-4991-A31A-182A07688A1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94913" y="4223290"/>
            <a:ext cx="2641736" cy="368319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6B52E1A0-0CEF-4030-B3A2-D883BC67B3C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94914" y="4757994"/>
            <a:ext cx="2609984" cy="327628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35E1BB22-EC19-473F-A46C-E04734FD37E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50461" y="5353566"/>
            <a:ext cx="2648086" cy="368319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1A96F71E-32A2-4439-9EF3-CF0EB728A042}"/>
              </a:ext>
            </a:extLst>
          </p:cNvPr>
          <p:cNvSpPr txBox="1"/>
          <p:nvPr/>
        </p:nvSpPr>
        <p:spPr>
          <a:xfrm>
            <a:off x="765313" y="4223290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SD95</a:t>
            </a:r>
            <a:endParaRPr lang="zh-CN" altLang="en-US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3F02E4B9-A6D7-41D9-B518-F405E95DC75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927228" y="2719841"/>
            <a:ext cx="2730640" cy="438173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0DA7E6B1-49C5-4B02-AB3D-366D423A8FED}"/>
              </a:ext>
            </a:extLst>
          </p:cNvPr>
          <p:cNvSpPr txBox="1"/>
          <p:nvPr/>
        </p:nvSpPr>
        <p:spPr>
          <a:xfrm>
            <a:off x="6134200" y="2788682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KT</a:t>
            </a:r>
            <a:endParaRPr lang="zh-CN" altLang="en-US" dirty="0"/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CF0082D8-4509-4D30-B9E0-99F28FA2B22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197420" y="4423847"/>
            <a:ext cx="2686188" cy="450873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D589E610-F28A-4173-A93D-A7462AFACB6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134199" y="4988791"/>
            <a:ext cx="2789647" cy="408078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41C08855-B504-49A9-91E5-BF61262DEEA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149521" y="5474529"/>
            <a:ext cx="2734087" cy="423783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0997F79-908E-4F5F-90F6-CCCF4D29A21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197420" y="5940516"/>
            <a:ext cx="2726426" cy="439297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AA83F92B-F1F1-43B5-AB68-4D32D2968FE6}"/>
              </a:ext>
            </a:extLst>
          </p:cNvPr>
          <p:cNvSpPr txBox="1"/>
          <p:nvPr/>
        </p:nvSpPr>
        <p:spPr>
          <a:xfrm>
            <a:off x="5178287" y="5237922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yt</a:t>
            </a:r>
            <a:r>
              <a:rPr lang="en-US" altLang="zh-CN" dirty="0"/>
              <a:t> 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87290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368F084-2731-44A6-BFA9-1CFBA08752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5691" y="885812"/>
            <a:ext cx="3580763" cy="71438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767183C-170C-4A84-8B9A-BDB4D728C9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5691" y="1988228"/>
            <a:ext cx="3580762" cy="68684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DCC2D0C-CF76-4BDB-9E8B-68D9639DB3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5690" y="3063102"/>
            <a:ext cx="3580761" cy="749037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86FC28A-D2E3-463A-AA4D-C6C1B0AE71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35689" y="4024732"/>
            <a:ext cx="3580761" cy="716152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2689B95D-AB6E-4CF5-A3BE-9773276A6FBA}"/>
              </a:ext>
            </a:extLst>
          </p:cNvPr>
          <p:cNvSpPr txBox="1"/>
          <p:nvPr/>
        </p:nvSpPr>
        <p:spPr>
          <a:xfrm>
            <a:off x="655983" y="1013791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rkB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C01FA92-4BD4-42EA-BF0D-FBB6406449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20158" y="926317"/>
            <a:ext cx="2641736" cy="33656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067522D-83CC-48F5-9716-DA3701BA567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20158" y="1457317"/>
            <a:ext cx="2660787" cy="28576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A1CDC1A-EAC3-4A80-B45B-F2A1265B601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87405" y="3250286"/>
            <a:ext cx="2460183" cy="35230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59B4420-5D89-4DEA-97CC-93C481B09B4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87405" y="3812140"/>
            <a:ext cx="2460183" cy="34477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9BEDF3C0-F000-4913-A016-FD312C3B781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20158" y="4373993"/>
            <a:ext cx="2527430" cy="41277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60432E8-171B-4DCB-AF42-A666414675A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185232" y="4914883"/>
            <a:ext cx="2527430" cy="389311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03671286-A33B-4761-9F76-537433187E16}"/>
              </a:ext>
            </a:extLst>
          </p:cNvPr>
          <p:cNvSpPr txBox="1"/>
          <p:nvPr/>
        </p:nvSpPr>
        <p:spPr>
          <a:xfrm>
            <a:off x="6096000" y="371723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321CED5-5DBD-40C5-8015-76317D6A24E1}"/>
              </a:ext>
            </a:extLst>
          </p:cNvPr>
          <p:cNvSpPr txBox="1"/>
          <p:nvPr/>
        </p:nvSpPr>
        <p:spPr>
          <a:xfrm>
            <a:off x="6096000" y="1162878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DNF</a:t>
            </a:r>
            <a:endParaRPr lang="zh-CN" altLang="en-US" dirty="0"/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AA833105-EA0D-47EC-8147-20B9279934C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20158" y="1937514"/>
            <a:ext cx="2641736" cy="364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3973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CF995924-421B-D049-8C42-8E1F8E7D31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3788" y="2957514"/>
            <a:ext cx="2298700" cy="4714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87E4581-D73F-AD44-B9D2-9DCE5F905D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3788" y="1535878"/>
            <a:ext cx="2298700" cy="3484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C8A92F1-10F9-274B-A48E-585A5A2F5B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7550" y="715176"/>
            <a:ext cx="5676900" cy="11049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95E6EF8-F21A-DC46-9439-FB28B49824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9012" y="3987800"/>
            <a:ext cx="5943600" cy="8255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387902AC-416B-3743-BF78-2D2F26EB66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5688" y="2524128"/>
            <a:ext cx="2336800" cy="330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B894DEE-7872-B74F-90B0-C594EF0F5E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29012" y="2854328"/>
            <a:ext cx="5829300" cy="7366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64C52CE6-ABF0-414D-9560-DD67A9F47EE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5688" y="3546473"/>
            <a:ext cx="2311400" cy="457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3AA8FD72-030A-FE4E-A251-44FF7B9A59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14712" y="4825206"/>
            <a:ext cx="6057900" cy="10287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6B12F59-7D1E-9845-B10D-6343C41C14A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5688" y="2035181"/>
            <a:ext cx="2336800" cy="393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6EF409B9-5414-7548-9513-CD9F910B523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25287"/>
          <a:stretch/>
        </p:blipFill>
        <p:spPr>
          <a:xfrm>
            <a:off x="3257550" y="1949459"/>
            <a:ext cx="6299200" cy="82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3223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2FBA238-A2A5-4F9F-8B00-EBB718F3D5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6655" y="3228964"/>
            <a:ext cx="2629035" cy="40007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EC4A668-988D-48BB-B71D-489B861026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5827" y="3886467"/>
            <a:ext cx="2635385" cy="31751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BFB2D62-E812-4297-8735-248CEC1C5D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6801" y="2124066"/>
            <a:ext cx="2698889" cy="32386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A4293C7-3990-470D-AC5B-EAC7915426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22530" y="2705091"/>
            <a:ext cx="2527430" cy="26671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4C0333EC-BC96-416D-9509-3D08BA7A3D50}"/>
              </a:ext>
            </a:extLst>
          </p:cNvPr>
          <p:cNvSpPr txBox="1"/>
          <p:nvPr/>
        </p:nvSpPr>
        <p:spPr>
          <a:xfrm>
            <a:off x="318052" y="2285999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fn2</a:t>
            </a:r>
            <a:endParaRPr lang="zh-CN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4895B9AE-2049-4D27-B5BB-C0B4FC2D43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1087" y="1260189"/>
            <a:ext cx="2870348" cy="361969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E4A269C-9C58-4D8B-B431-2360C0B16A0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51087" y="1801318"/>
            <a:ext cx="2870348" cy="41277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C713E35-AC02-4E19-8A21-158BC088C9F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51087" y="2447933"/>
            <a:ext cx="2870348" cy="39866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4E49B68C-661F-4811-8A27-4EEBF51CDC9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51087" y="3028928"/>
            <a:ext cx="2870348" cy="394399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5569AE8E-D2B8-40B6-9DBA-86AEDF2E2CD2}"/>
              </a:ext>
            </a:extLst>
          </p:cNvPr>
          <p:cNvSpPr txBox="1"/>
          <p:nvPr/>
        </p:nvSpPr>
        <p:spPr>
          <a:xfrm>
            <a:off x="5095424" y="1761507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omm2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52580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3</TotalTime>
  <Words>18</Words>
  <Application>Microsoft Macintosh PowerPoint</Application>
  <PresentationFormat>宽屏</PresentationFormat>
  <Paragraphs>16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v</dc:creator>
  <cp:lastModifiedBy>姜 宁</cp:lastModifiedBy>
  <cp:revision>58</cp:revision>
  <dcterms:created xsi:type="dcterms:W3CDTF">2021-03-24T13:11:02Z</dcterms:created>
  <dcterms:modified xsi:type="dcterms:W3CDTF">2022-08-31T03:40:45Z</dcterms:modified>
</cp:coreProperties>
</file>